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327650" cy="882015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6F570D-41B1-48DD-BBCD-EE382B7E212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66400" y="353880"/>
            <a:ext cx="4794120" cy="14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66400" y="2057400"/>
            <a:ext cx="4794120" cy="2776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66400" y="5098320"/>
            <a:ext cx="4794120" cy="2776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A1C01D-6A62-4A7D-9B02-671913E939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66400" y="353880"/>
            <a:ext cx="4794120" cy="14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66400" y="2057400"/>
            <a:ext cx="2339280" cy="2776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723040" y="2057400"/>
            <a:ext cx="2339280" cy="2776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66400" y="5098320"/>
            <a:ext cx="2339280" cy="2776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723040" y="5098320"/>
            <a:ext cx="2339280" cy="2776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322A23-2A8D-4022-A475-14FEB827025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66400" y="353880"/>
            <a:ext cx="4794120" cy="14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66400" y="2057400"/>
            <a:ext cx="1543320" cy="2776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887120" y="2057400"/>
            <a:ext cx="1543320" cy="2776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508200" y="2057400"/>
            <a:ext cx="1543320" cy="2776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66400" y="5098320"/>
            <a:ext cx="1543320" cy="2776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887120" y="5098320"/>
            <a:ext cx="1543320" cy="2776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508200" y="5098320"/>
            <a:ext cx="1543320" cy="2776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91DBC4-D5B0-48F1-A5F9-4F5DDC0348D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66400" y="353880"/>
            <a:ext cx="4794120" cy="14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66400" y="2057400"/>
            <a:ext cx="4794120" cy="5821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01"/>
              </a:spcBef>
              <a:buNone/>
              <a:tabLst>
                <a:tab algn="l" pos="0"/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81CAA0-09A9-401D-B37A-372141CB51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66400" y="353880"/>
            <a:ext cx="4794120" cy="14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66400" y="2057400"/>
            <a:ext cx="4794120" cy="582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1F3AC8-4657-4ED6-BC10-4BFCBA9DCE5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66400" y="353880"/>
            <a:ext cx="4794120" cy="14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66400" y="2057400"/>
            <a:ext cx="2339280" cy="582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723040" y="2057400"/>
            <a:ext cx="2339280" cy="582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7D8B39-A5BA-47AF-BFE8-04CFADA179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66400" y="353880"/>
            <a:ext cx="4794120" cy="14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D2B8AA-CA56-4BD0-A12C-62A4A809BD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66400" y="353880"/>
            <a:ext cx="4794120" cy="6816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01"/>
              </a:spcBef>
              <a:tabLst>
                <a:tab algn="l" pos="0"/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0F9E33-1FC0-40D3-9531-4FD6F7D0BA4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66400" y="353880"/>
            <a:ext cx="4794120" cy="14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66400" y="2057400"/>
            <a:ext cx="2339280" cy="2776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723040" y="2057400"/>
            <a:ext cx="2339280" cy="582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66400" y="5098320"/>
            <a:ext cx="2339280" cy="2776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801C3A-9F31-487F-AE61-185C35B7E2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66400" y="353880"/>
            <a:ext cx="4794120" cy="14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66400" y="2057400"/>
            <a:ext cx="2339280" cy="582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723040" y="2057400"/>
            <a:ext cx="2339280" cy="2776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723040" y="5098320"/>
            <a:ext cx="2339280" cy="2776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320C74-4E54-4766-89D2-003450D79FC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66400" y="353880"/>
            <a:ext cx="4794120" cy="14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66400" y="2057400"/>
            <a:ext cx="2339280" cy="2776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723040" y="2057400"/>
            <a:ext cx="2339280" cy="2776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66400" y="5098320"/>
            <a:ext cx="4794120" cy="2776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F89C3B-D081-46C9-A9F9-D701809031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66400" y="353880"/>
            <a:ext cx="4794120" cy="14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66400" y="2057400"/>
            <a:ext cx="4794120" cy="582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64960" indent="-26496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1" marL="576360" indent="-22068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2" marL="887400" indent="-17604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3" marL="1243080" indent="-17640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4" marL="1596960" indent="-176040">
              <a:spcBef>
                <a:spcPts val="601"/>
              </a:spcBef>
              <a:buClr>
                <a:srgbClr val="000000"/>
              </a:buClr>
              <a:buFont typeface="Arial"/>
              <a:buChar char="»"/>
              <a:tabLst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5" marL="1596960" indent="-176040">
              <a:spcBef>
                <a:spcPts val="601"/>
              </a:spcBef>
              <a:buClr>
                <a:srgbClr val="000000"/>
              </a:buClr>
              <a:buFont typeface="Arial"/>
              <a:buChar char="»"/>
              <a:tabLst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6" marL="1596960" indent="-176040">
              <a:spcBef>
                <a:spcPts val="601"/>
              </a:spcBef>
              <a:buClr>
                <a:srgbClr val="000000"/>
              </a:buClr>
              <a:buFont typeface="Arial"/>
              <a:buChar char="»"/>
              <a:tabLst>
                <a:tab algn="l" pos="353880"/>
                <a:tab algn="l" pos="708120"/>
                <a:tab algn="l" pos="1062000"/>
                <a:tab algn="l" pos="1415880"/>
                <a:tab algn="l" pos="1770120"/>
                <a:tab algn="l" pos="2124000"/>
                <a:tab algn="l" pos="2478240"/>
                <a:tab algn="l" pos="2832120"/>
                <a:tab algn="l" pos="3186000"/>
                <a:tab algn="l" pos="3540240"/>
                <a:tab algn="l" pos="3894120"/>
                <a:tab algn="l" pos="4248000"/>
                <a:tab algn="l" pos="4602240"/>
                <a:tab algn="l" pos="4956120"/>
                <a:tab algn="l" pos="5310360"/>
                <a:tab algn="l" pos="5664240"/>
                <a:tab algn="l" pos="6018120"/>
                <a:tab algn="l" pos="6372360"/>
                <a:tab algn="l" pos="6726240"/>
                <a:tab algn="l" pos="708012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66400" y="8175240"/>
            <a:ext cx="1243080" cy="4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385920"/>
                <a:tab algn="l" pos="771480"/>
                <a:tab algn="l" pos="1157400"/>
                <a:tab algn="l" pos="1542960"/>
                <a:tab algn="l" pos="1928880"/>
                <a:tab algn="l" pos="2314440"/>
                <a:tab algn="l" pos="2700360"/>
                <a:tab algn="l" pos="3086280"/>
                <a:tab algn="l" pos="3471840"/>
                <a:tab algn="l" pos="3857760"/>
                <a:tab algn="l" pos="4243320"/>
                <a:tab algn="l" pos="4629240"/>
                <a:tab algn="l" pos="5014800"/>
                <a:tab algn="l" pos="5400720"/>
                <a:tab algn="l" pos="5786280"/>
                <a:tab algn="l" pos="6172200"/>
                <a:tab algn="l" pos="6558120"/>
                <a:tab algn="l" pos="6943680"/>
                <a:tab algn="l" pos="7329600"/>
                <a:tab algn="l" pos="7715160"/>
              </a:tabLst>
              <a:defRPr b="0" lang="zh-CN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385920"/>
                <a:tab algn="l" pos="771480"/>
                <a:tab algn="l" pos="1157400"/>
                <a:tab algn="l" pos="1542960"/>
                <a:tab algn="l" pos="1928880"/>
                <a:tab algn="l" pos="2314440"/>
                <a:tab algn="l" pos="2700360"/>
                <a:tab algn="l" pos="3086280"/>
                <a:tab algn="l" pos="3471840"/>
                <a:tab algn="l" pos="3857760"/>
                <a:tab algn="l" pos="4243320"/>
                <a:tab algn="l" pos="4629240"/>
                <a:tab algn="l" pos="5014800"/>
                <a:tab algn="l" pos="5400720"/>
                <a:tab algn="l" pos="5786280"/>
                <a:tab algn="l" pos="6172200"/>
                <a:tab algn="l" pos="6558120"/>
                <a:tab algn="l" pos="6943680"/>
                <a:tab algn="l" pos="7329600"/>
                <a:tab algn="l" pos="7715160"/>
              </a:tabLst>
            </a:pPr>
            <a:r>
              <a:rPr b="0" lang="zh-CN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820520" y="8175240"/>
            <a:ext cx="1685880" cy="4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385920"/>
                <a:tab algn="l" pos="771480"/>
                <a:tab algn="l" pos="1157400"/>
                <a:tab algn="l" pos="1542960"/>
                <a:tab algn="l" pos="1928880"/>
                <a:tab algn="l" pos="2314440"/>
                <a:tab algn="l" pos="2700360"/>
                <a:tab algn="l" pos="3086280"/>
                <a:tab algn="l" pos="3471840"/>
                <a:tab algn="l" pos="3857760"/>
                <a:tab algn="l" pos="4243320"/>
                <a:tab algn="l" pos="4629240"/>
                <a:tab algn="l" pos="5014800"/>
                <a:tab algn="l" pos="5400720"/>
                <a:tab algn="l" pos="5786280"/>
                <a:tab algn="l" pos="6172200"/>
                <a:tab algn="l" pos="6558120"/>
                <a:tab algn="l" pos="6943680"/>
                <a:tab algn="l" pos="7329600"/>
                <a:tab algn="l" pos="771516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817440" y="8175240"/>
            <a:ext cx="1243080" cy="4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385920"/>
                <a:tab algn="l" pos="771480"/>
                <a:tab algn="l" pos="1157400"/>
                <a:tab algn="l" pos="1542960"/>
                <a:tab algn="l" pos="1928880"/>
                <a:tab algn="l" pos="2314440"/>
                <a:tab algn="l" pos="2700360"/>
                <a:tab algn="l" pos="3086280"/>
                <a:tab algn="l" pos="3471840"/>
                <a:tab algn="l" pos="3857760"/>
                <a:tab algn="l" pos="4243320"/>
                <a:tab algn="l" pos="4629240"/>
                <a:tab algn="l" pos="5014800"/>
                <a:tab algn="l" pos="5400720"/>
                <a:tab algn="l" pos="5786280"/>
                <a:tab algn="l" pos="6172200"/>
                <a:tab algn="l" pos="6558120"/>
                <a:tab algn="l" pos="6943680"/>
                <a:tab algn="l" pos="7329600"/>
                <a:tab algn="l" pos="7715160"/>
              </a:tabLst>
              <a:defRPr b="0" lang="zh-CN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385920"/>
                <a:tab algn="l" pos="771480"/>
                <a:tab algn="l" pos="1157400"/>
                <a:tab algn="l" pos="1542960"/>
                <a:tab algn="l" pos="1928880"/>
                <a:tab algn="l" pos="2314440"/>
                <a:tab algn="l" pos="2700360"/>
                <a:tab algn="l" pos="3086280"/>
                <a:tab algn="l" pos="3471840"/>
                <a:tab algn="l" pos="3857760"/>
                <a:tab algn="l" pos="4243320"/>
                <a:tab algn="l" pos="4629240"/>
                <a:tab algn="l" pos="5014800"/>
                <a:tab algn="l" pos="5400720"/>
                <a:tab algn="l" pos="5786280"/>
                <a:tab algn="l" pos="6172200"/>
                <a:tab algn="l" pos="6558120"/>
                <a:tab algn="l" pos="6943680"/>
                <a:tab algn="l" pos="7329600"/>
                <a:tab algn="l" pos="7715160"/>
              </a:tabLst>
            </a:pPr>
            <a:fld id="{74E5E656-97EF-4ED8-A487-6F32AB44A7D5}" type="slidenum">
              <a:rPr b="0" lang="zh-CN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1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7"/>
          <p:cNvSpPr/>
          <p:nvPr/>
        </p:nvSpPr>
        <p:spPr>
          <a:xfrm>
            <a:off x="4297320" y="2090880"/>
            <a:ext cx="428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85920"/>
                <a:tab algn="l" pos="771480"/>
                <a:tab algn="l" pos="1157400"/>
                <a:tab algn="l" pos="1542960"/>
                <a:tab algn="l" pos="1928880"/>
                <a:tab algn="l" pos="2314440"/>
                <a:tab algn="l" pos="2700360"/>
                <a:tab algn="l" pos="3086280"/>
                <a:tab algn="l" pos="3471840"/>
                <a:tab algn="l" pos="3857760"/>
                <a:tab algn="l" pos="4243320"/>
                <a:tab algn="l" pos="4629240"/>
                <a:tab algn="l" pos="5014800"/>
                <a:tab algn="l" pos="5400720"/>
                <a:tab algn="l" pos="5786280"/>
                <a:tab algn="l" pos="6172200"/>
                <a:tab algn="l" pos="6558120"/>
                <a:tab algn="l" pos="6943680"/>
                <a:tab algn="l" pos="7329600"/>
                <a:tab algn="l" pos="771516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W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9"/>
          <p:cNvSpPr/>
          <p:nvPr/>
        </p:nvSpPr>
        <p:spPr>
          <a:xfrm>
            <a:off x="4297320" y="2602080"/>
            <a:ext cx="43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85920"/>
                <a:tab algn="l" pos="771480"/>
                <a:tab algn="l" pos="1157400"/>
                <a:tab algn="l" pos="1542960"/>
                <a:tab algn="l" pos="1928880"/>
                <a:tab algn="l" pos="2314440"/>
                <a:tab algn="l" pos="2700360"/>
                <a:tab algn="l" pos="3086280"/>
                <a:tab algn="l" pos="3471840"/>
                <a:tab algn="l" pos="3857760"/>
                <a:tab algn="l" pos="4243320"/>
                <a:tab algn="l" pos="4629240"/>
                <a:tab algn="l" pos="5014800"/>
                <a:tab algn="l" pos="5400720"/>
                <a:tab algn="l" pos="5786280"/>
                <a:tab algn="l" pos="6172200"/>
                <a:tab algn="l" pos="6558120"/>
                <a:tab algn="l" pos="6943680"/>
                <a:tab algn="l" pos="7329600"/>
                <a:tab algn="l" pos="771516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W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16"/>
          <p:cNvSpPr/>
          <p:nvPr/>
        </p:nvSpPr>
        <p:spPr>
          <a:xfrm rot="12575400">
            <a:off x="4010040" y="1010880"/>
            <a:ext cx="362880" cy="92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85920"/>
                <a:tab algn="l" pos="771480"/>
                <a:tab algn="l" pos="1157400"/>
                <a:tab algn="l" pos="1542960"/>
                <a:tab algn="l" pos="1928880"/>
                <a:tab algn="l" pos="2314440"/>
                <a:tab algn="l" pos="2700360"/>
                <a:tab algn="l" pos="3086280"/>
                <a:tab algn="l" pos="3471840"/>
                <a:tab algn="l" pos="3857760"/>
                <a:tab algn="l" pos="4243320"/>
                <a:tab algn="l" pos="4629240"/>
                <a:tab algn="l" pos="5014800"/>
                <a:tab algn="l" pos="5400720"/>
                <a:tab algn="l" pos="5786280"/>
                <a:tab algn="l" pos="6172200"/>
                <a:tab algn="l" pos="6558120"/>
                <a:tab algn="l" pos="6943680"/>
                <a:tab algn="l" pos="7329600"/>
                <a:tab algn="l" pos="771516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A-BARX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15"/>
          <p:cNvSpPr/>
          <p:nvPr/>
        </p:nvSpPr>
        <p:spPr>
          <a:xfrm rot="12575400">
            <a:off x="3327480" y="1223280"/>
            <a:ext cx="362880" cy="69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85920"/>
                <a:tab algn="l" pos="771480"/>
                <a:tab algn="l" pos="1157400"/>
                <a:tab algn="l" pos="1542960"/>
                <a:tab algn="l" pos="1928880"/>
                <a:tab algn="l" pos="2314440"/>
                <a:tab algn="l" pos="2700360"/>
                <a:tab algn="l" pos="3086280"/>
                <a:tab algn="l" pos="3471840"/>
                <a:tab algn="l" pos="3857760"/>
                <a:tab algn="l" pos="4243320"/>
                <a:tab algn="l" pos="4629240"/>
                <a:tab algn="l" pos="5014800"/>
                <a:tab algn="l" pos="5400720"/>
                <a:tab algn="l" pos="5786280"/>
                <a:tab algn="l" pos="6172200"/>
                <a:tab algn="l" pos="6558120"/>
                <a:tab algn="l" pos="6943680"/>
                <a:tab algn="l" pos="7329600"/>
                <a:tab algn="l" pos="771516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Vecto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5" name="Picture 2" descr="D:\china\Data\BARX1\Root\OFCD\AR-red staining 4 weeks 02-12-07 in OFCD.jpg"/>
          <p:cNvPicPr/>
          <p:nvPr/>
        </p:nvPicPr>
        <p:blipFill>
          <a:blip r:embed="rId1"/>
          <a:srcRect l="11518" t="14387" r="35381" b="46269"/>
          <a:stretch/>
        </p:blipFill>
        <p:spPr>
          <a:xfrm>
            <a:off x="3108240" y="2475000"/>
            <a:ext cx="1189080" cy="62208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44" descr="D:\备份 2015-6-23\china\课题组及研究生\林潇\BARX1\manuscript\2018-11-5\0天染色结果\Sfigure3.tif"/>
          <p:cNvPicPr/>
          <p:nvPr/>
        </p:nvPicPr>
        <p:blipFill>
          <a:blip r:embed="rId2"/>
          <a:srcRect l="7798" t="73234" r="37818" b="6709"/>
          <a:stretch/>
        </p:blipFill>
        <p:spPr>
          <a:xfrm>
            <a:off x="3108240" y="1860480"/>
            <a:ext cx="1189080" cy="604800"/>
          </a:xfrm>
          <a:prstGeom prst="rect">
            <a:avLst/>
          </a:prstGeom>
          <a:ln w="0">
            <a:noFill/>
          </a:ln>
        </p:spPr>
      </p:pic>
      <p:sp>
        <p:nvSpPr>
          <p:cNvPr id="47" name="TextBox 43"/>
          <p:cNvSpPr/>
          <p:nvPr/>
        </p:nvSpPr>
        <p:spPr>
          <a:xfrm>
            <a:off x="101880" y="719280"/>
            <a:ext cx="2289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85920"/>
                <a:tab algn="l" pos="771480"/>
                <a:tab algn="l" pos="1157400"/>
                <a:tab algn="l" pos="1542960"/>
                <a:tab algn="l" pos="1928880"/>
                <a:tab algn="l" pos="2314440"/>
                <a:tab algn="l" pos="2700360"/>
                <a:tab algn="l" pos="3086280"/>
                <a:tab algn="l" pos="3471840"/>
                <a:tab algn="l" pos="3857760"/>
                <a:tab algn="l" pos="4243320"/>
                <a:tab algn="l" pos="4629240"/>
                <a:tab algn="l" pos="5014800"/>
                <a:tab algn="l" pos="5400720"/>
                <a:tab algn="l" pos="5786280"/>
                <a:tab algn="l" pos="6172200"/>
                <a:tab algn="l" pos="6558120"/>
                <a:tab algn="l" pos="6943680"/>
                <a:tab algn="l" pos="7329600"/>
                <a:tab algn="l" pos="771516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Original Supplementary Figure 3B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44"/>
          <p:cNvSpPr/>
          <p:nvPr/>
        </p:nvSpPr>
        <p:spPr>
          <a:xfrm>
            <a:off x="2743920" y="695160"/>
            <a:ext cx="2423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85920"/>
                <a:tab algn="l" pos="771480"/>
                <a:tab algn="l" pos="1157400"/>
                <a:tab algn="l" pos="1542960"/>
                <a:tab algn="l" pos="1928880"/>
                <a:tab algn="l" pos="2314440"/>
                <a:tab algn="l" pos="2700360"/>
                <a:tab algn="l" pos="3086280"/>
                <a:tab algn="l" pos="3471840"/>
                <a:tab algn="l" pos="3857760"/>
                <a:tab algn="l" pos="4243320"/>
                <a:tab algn="l" pos="4629240"/>
                <a:tab algn="l" pos="5014800"/>
                <a:tab algn="l" pos="5400720"/>
                <a:tab algn="l" pos="5786280"/>
                <a:tab algn="l" pos="6172200"/>
                <a:tab algn="l" pos="6558120"/>
                <a:tab algn="l" pos="6943680"/>
                <a:tab algn="l" pos="7329600"/>
                <a:tab algn="l" pos="771516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Corrected Supplementary Figure 3B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Picture 5" descr="D:\data\old\SCAP and OFCD\0\AR-red label.jpg"/>
          <p:cNvPicPr/>
          <p:nvPr/>
        </p:nvPicPr>
        <p:blipFill>
          <a:blip r:embed="rId3"/>
          <a:srcRect l="2140" t="50044" r="2140" b="5034"/>
          <a:stretch/>
        </p:blipFill>
        <p:spPr>
          <a:xfrm>
            <a:off x="735120" y="1814400"/>
            <a:ext cx="1143000" cy="62100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2" descr="D:\china\Data\BARX1\Root\OFCD\AR-red staining 4 weeks 02-12-07 in OFCD.jpg"/>
          <p:cNvPicPr/>
          <p:nvPr/>
        </p:nvPicPr>
        <p:blipFill>
          <a:blip r:embed="rId4"/>
          <a:srcRect l="11518" t="14387" r="35381" b="46269"/>
          <a:stretch/>
        </p:blipFill>
        <p:spPr>
          <a:xfrm>
            <a:off x="735120" y="2454120"/>
            <a:ext cx="1143000" cy="598680"/>
          </a:xfrm>
          <a:prstGeom prst="rect">
            <a:avLst/>
          </a:prstGeom>
          <a:ln w="0">
            <a:noFill/>
          </a:ln>
        </p:spPr>
      </p:pic>
      <p:sp>
        <p:nvSpPr>
          <p:cNvPr id="51" name="TextBox 16"/>
          <p:cNvSpPr/>
          <p:nvPr/>
        </p:nvSpPr>
        <p:spPr>
          <a:xfrm rot="12575400">
            <a:off x="1590840" y="955440"/>
            <a:ext cx="362880" cy="92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85920"/>
                <a:tab algn="l" pos="771480"/>
                <a:tab algn="l" pos="1157400"/>
                <a:tab algn="l" pos="1542960"/>
                <a:tab algn="l" pos="1928880"/>
                <a:tab algn="l" pos="2314440"/>
                <a:tab algn="l" pos="2700360"/>
                <a:tab algn="l" pos="3086280"/>
                <a:tab algn="l" pos="3471840"/>
                <a:tab algn="l" pos="3857760"/>
                <a:tab algn="l" pos="4243320"/>
                <a:tab algn="l" pos="4629240"/>
                <a:tab algn="l" pos="5014800"/>
                <a:tab algn="l" pos="5400720"/>
                <a:tab algn="l" pos="5786280"/>
                <a:tab algn="l" pos="6172200"/>
                <a:tab algn="l" pos="6558120"/>
                <a:tab algn="l" pos="6943680"/>
                <a:tab algn="l" pos="7329600"/>
                <a:tab algn="l" pos="771516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A-BARX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5"/>
          <p:cNvSpPr/>
          <p:nvPr/>
        </p:nvSpPr>
        <p:spPr>
          <a:xfrm rot="12575400">
            <a:off x="954360" y="1167480"/>
            <a:ext cx="362880" cy="69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85920"/>
                <a:tab algn="l" pos="771480"/>
                <a:tab algn="l" pos="1157400"/>
                <a:tab algn="l" pos="1542960"/>
                <a:tab algn="l" pos="1928880"/>
                <a:tab algn="l" pos="2314440"/>
                <a:tab algn="l" pos="2700360"/>
                <a:tab algn="l" pos="3086280"/>
                <a:tab algn="l" pos="3471840"/>
                <a:tab algn="l" pos="3857760"/>
                <a:tab algn="l" pos="4243320"/>
                <a:tab algn="l" pos="4629240"/>
                <a:tab algn="l" pos="5014800"/>
                <a:tab algn="l" pos="5400720"/>
                <a:tab algn="l" pos="5786280"/>
                <a:tab algn="l" pos="6172200"/>
                <a:tab algn="l" pos="6558120"/>
                <a:tab algn="l" pos="6943680"/>
                <a:tab algn="l" pos="7329600"/>
                <a:tab algn="l" pos="771516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Vecto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7"/>
          <p:cNvSpPr/>
          <p:nvPr/>
        </p:nvSpPr>
        <p:spPr>
          <a:xfrm>
            <a:off x="1806480" y="1981080"/>
            <a:ext cx="428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85920"/>
                <a:tab algn="l" pos="771480"/>
                <a:tab algn="l" pos="1157400"/>
                <a:tab algn="l" pos="1542960"/>
                <a:tab algn="l" pos="1928880"/>
                <a:tab algn="l" pos="2314440"/>
                <a:tab algn="l" pos="2700360"/>
                <a:tab algn="l" pos="3086280"/>
                <a:tab algn="l" pos="3471840"/>
                <a:tab algn="l" pos="3857760"/>
                <a:tab algn="l" pos="4243320"/>
                <a:tab algn="l" pos="4629240"/>
                <a:tab algn="l" pos="5014800"/>
                <a:tab algn="l" pos="5400720"/>
                <a:tab algn="l" pos="5786280"/>
                <a:tab algn="l" pos="6172200"/>
                <a:tab algn="l" pos="6558120"/>
                <a:tab algn="l" pos="6943680"/>
                <a:tab algn="l" pos="7329600"/>
                <a:tab algn="l" pos="771516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W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9"/>
          <p:cNvSpPr/>
          <p:nvPr/>
        </p:nvSpPr>
        <p:spPr>
          <a:xfrm>
            <a:off x="1806480" y="2563920"/>
            <a:ext cx="43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85920"/>
                <a:tab algn="l" pos="771480"/>
                <a:tab algn="l" pos="1157400"/>
                <a:tab algn="l" pos="1542960"/>
                <a:tab algn="l" pos="1928880"/>
                <a:tab algn="l" pos="2314440"/>
                <a:tab algn="l" pos="2700360"/>
                <a:tab algn="l" pos="3086280"/>
                <a:tab algn="l" pos="3471840"/>
                <a:tab algn="l" pos="3857760"/>
                <a:tab algn="l" pos="4243320"/>
                <a:tab algn="l" pos="4629240"/>
                <a:tab algn="l" pos="5014800"/>
                <a:tab algn="l" pos="5400720"/>
                <a:tab algn="l" pos="5786280"/>
                <a:tab algn="l" pos="6172200"/>
                <a:tab algn="l" pos="6558120"/>
                <a:tab algn="l" pos="6943680"/>
                <a:tab algn="l" pos="7329600"/>
                <a:tab algn="l" pos="771516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W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7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1-03T12:27:04Z</dcterms:created>
  <dc:creator>Daily Lin</dc:creator>
  <dc:description/>
  <dc:language>en-US</dc:language>
  <cp:lastModifiedBy>pc</cp:lastModifiedBy>
  <cp:lastPrinted>2018-05-17T08:21:29Z</cp:lastPrinted>
  <dcterms:modified xsi:type="dcterms:W3CDTF">2018-11-05T00:21:10Z</dcterms:modified>
  <cp:revision>437</cp:revision>
  <dc:subject/>
  <dc:title>PowerPoint 演示文稿</dc:title>
</cp:coreProperties>
</file>